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F01D02-902D-4BA7-9100-AFFE9E16FFD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6543A3-853C-48D0-87BD-58052FAAA0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78C334-E7B7-42F8-B9CB-6EF632E2604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6E8F7B-AA38-4F97-9753-EEB6F71E02F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34FF24-0D5A-4971-97F7-F2D76883B5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361DED-517A-405C-A121-28EA9E159B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727CCC-73DD-463E-9CDE-7C638C4C60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451F73-A28C-49DE-9B6D-9EF8DD01C5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47C87A-C0B1-4361-9817-06550C9E54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CA9117-C867-4F6B-8409-6418F03400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DF3E64-DCD1-4383-9B10-F54380168C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851602-135E-4C97-B818-8D4DDFC328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7282DD9-A4D2-43F0-AD5E-877BEE2A4BE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1593720" y="1300320"/>
            <a:ext cx="3600720" cy="36003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"/>
          <p:cNvPicPr/>
          <p:nvPr/>
        </p:nvPicPr>
        <p:blipFill>
          <a:blip r:embed="rId2"/>
          <a:stretch/>
        </p:blipFill>
        <p:spPr>
          <a:xfrm>
            <a:off x="1641600" y="5538960"/>
            <a:ext cx="3600360" cy="3600360"/>
          </a:xfrm>
          <a:prstGeom prst="rect">
            <a:avLst/>
          </a:prstGeom>
          <a:ln w="0">
            <a:noFill/>
          </a:ln>
        </p:spPr>
      </p:pic>
      <p:sp>
        <p:nvSpPr>
          <p:cNvPr id="43" name="TextBox 5"/>
          <p:cNvSpPr/>
          <p:nvPr/>
        </p:nvSpPr>
        <p:spPr>
          <a:xfrm>
            <a:off x="1202760" y="1117440"/>
            <a:ext cx="4077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Kaplan-Meier analysis of OTUB1 mRNA expression level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in 3455 breast cancer patients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1306800" y="5338800"/>
            <a:ext cx="4077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Kaplan-Meier analysis of OTUB1 mRNA expression level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in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WarnockPro-Regular"/>
              </a:rPr>
              <a:t>1926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 lung cancer patients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7"/>
          <p:cNvSpPr/>
          <p:nvPr/>
        </p:nvSpPr>
        <p:spPr>
          <a:xfrm>
            <a:off x="4646520" y="9553680"/>
            <a:ext cx="2302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1"/>
          <p:cNvSpPr/>
          <p:nvPr/>
        </p:nvSpPr>
        <p:spPr>
          <a:xfrm>
            <a:off x="124920" y="831960"/>
            <a:ext cx="38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8"/>
          <p:cNvSpPr/>
          <p:nvPr/>
        </p:nvSpPr>
        <p:spPr>
          <a:xfrm>
            <a:off x="175320" y="5068800"/>
            <a:ext cx="39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22T21:29:58Z</dcterms:created>
  <dc:creator>Eric Lam</dc:creator>
  <dc:description/>
  <dc:language>en-US</dc:language>
  <cp:lastModifiedBy>Satish.d</cp:lastModifiedBy>
  <cp:lastPrinted>2015-03-23T10:24:39Z</cp:lastPrinted>
  <dcterms:modified xsi:type="dcterms:W3CDTF">2015-06-25T11:25:34Z</dcterms:modified>
  <cp:revision>919</cp:revision>
  <dc:subject/>
  <dc:title>PowerPoint Presentation</dc:title>
</cp:coreProperties>
</file>